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4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9579D2-7430-41BB-BA05-F93DB0457132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54AEDA-26D6-4A4A-B7D9-37C995071E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04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0909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808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3189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715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66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983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646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1671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99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072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5166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962E8-0460-4432-BA02-FA52D090FC65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98DA4-485D-4F0A-925B-01D762EEF8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4715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3.wdp"/><Relationship Id="rId18" Type="http://schemas.openxmlformats.org/officeDocument/2006/relationships/image" Target="../media/image14.png"/><Relationship Id="rId26" Type="http://schemas.openxmlformats.org/officeDocument/2006/relationships/image" Target="../media/image21.png"/><Relationship Id="rId39" Type="http://schemas.microsoft.com/office/2007/relationships/hdphoto" Target="../media/hdphoto9.wdp"/><Relationship Id="rId3" Type="http://schemas.openxmlformats.org/officeDocument/2006/relationships/image" Target="../media/image2.png"/><Relationship Id="rId21" Type="http://schemas.openxmlformats.org/officeDocument/2006/relationships/image" Target="../media/image17.png"/><Relationship Id="rId34" Type="http://schemas.openxmlformats.org/officeDocument/2006/relationships/image" Target="../media/image26.png"/><Relationship Id="rId42" Type="http://schemas.openxmlformats.org/officeDocument/2006/relationships/image" Target="../media/image32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3.png"/><Relationship Id="rId25" Type="http://schemas.openxmlformats.org/officeDocument/2006/relationships/image" Target="../media/image20.jpeg"/><Relationship Id="rId33" Type="http://schemas.microsoft.com/office/2007/relationships/hdphoto" Target="../media/hdphoto7.wdp"/><Relationship Id="rId38" Type="http://schemas.openxmlformats.org/officeDocument/2006/relationships/image" Target="../media/image29.png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29" Type="http://schemas.openxmlformats.org/officeDocument/2006/relationships/image" Target="../media/image23.png"/><Relationship Id="rId41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24" Type="http://schemas.openxmlformats.org/officeDocument/2006/relationships/image" Target="../media/image19.png"/><Relationship Id="rId32" Type="http://schemas.openxmlformats.org/officeDocument/2006/relationships/image" Target="../media/image25.png"/><Relationship Id="rId37" Type="http://schemas.openxmlformats.org/officeDocument/2006/relationships/image" Target="../media/image28.png"/><Relationship Id="rId40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23" Type="http://schemas.openxmlformats.org/officeDocument/2006/relationships/image" Target="../media/image18.png"/><Relationship Id="rId28" Type="http://schemas.openxmlformats.org/officeDocument/2006/relationships/image" Target="../media/image22.jpeg"/><Relationship Id="rId36" Type="http://schemas.microsoft.com/office/2007/relationships/hdphoto" Target="../media/hdphoto8.wdp"/><Relationship Id="rId10" Type="http://schemas.openxmlformats.org/officeDocument/2006/relationships/image" Target="../media/image7.png"/><Relationship Id="rId19" Type="http://schemas.openxmlformats.org/officeDocument/2006/relationships/image" Target="../media/image15.png"/><Relationship Id="rId31" Type="http://schemas.openxmlformats.org/officeDocument/2006/relationships/image" Target="../media/image24.png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0.png"/><Relationship Id="rId22" Type="http://schemas.microsoft.com/office/2007/relationships/hdphoto" Target="../media/hdphoto4.wdp"/><Relationship Id="rId27" Type="http://schemas.microsoft.com/office/2007/relationships/hdphoto" Target="../media/hdphoto5.wdp"/><Relationship Id="rId30" Type="http://schemas.microsoft.com/office/2007/relationships/hdphoto" Target="../media/hdphoto6.wdp"/><Relationship Id="rId35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Maciek\Desktop\figure\vnm7.png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0712" y="45720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Maciek\Desktop\figure\24hacidh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312" y="45720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3" descr="C:\Users\Maciek\Desktop\figure\1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312" y="11844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7" descr="C:\Users\Maciek\Desktop\figure\12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1951" y="1182982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4" descr="C:\Users\Maciek\Desktop\figure\2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712" y="11844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6" descr="C:\Users\Maciek\Desktop\figure\23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112" y="11844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20" descr="C:\Users\Maciek\Desktop\figure\dfcv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312" y="23148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3" descr="C:\Users\Maciek\Desktop\figure\poikl1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532" y="23148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1" descr="C:\Users\Maciek\Desktop\figure\bnmk.pn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712" y="23148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5" descr="C:\Users\Maciek\Desktop\figure\xxccvb12345.png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112" y="23148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9" descr="C:\Users\Maciek\Desktop\figure\EEA1-DDR2-DAPI-t-24h-collagen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312" y="34452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C:\Users\Maciek\Desktop\figure\total - composite t=24h.png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125" y="34452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8" descr="C:\Users\Maciek\Desktop\figure\EEA1-py1000--DAPI-t-24h-collagen.pn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712" y="34452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3" descr="C:\Users\Maciek\Desktop\figure\Composite-t24-phospho eea1.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113" y="3445200"/>
            <a:ext cx="266747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1" descr="C:\Users\Maciek\Desktop\figure\1.pn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312" y="45720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8" descr="C:\Users\Maciek\Desktop\figure\67.pn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712" y="45720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2" descr="C:\Users\Maciek\Desktop\figure\2.pn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712" y="45720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9" descr="C:\Users\Maciek\Desktop\figure\68.pn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112" y="45720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8" descr="C:\Users\Maciek\Desktop\figure\oooip.pn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312" y="11844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4" descr="C:\Users\Maciek\Desktop\figure\otk.jpg"/>
          <p:cNvPicPr preferRelativeResize="0"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0712" y="11844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9" descr="C:\Users\Maciek\Desktop\figure\ppppp.pn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8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6111" y="11844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0" descr="C:\Users\Maciek\Desktop\figure\cnmq.jpg"/>
          <p:cNvPicPr preferRelativeResize="0"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475" y="11844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30" descr="C:\Users\Maciek\Desktop\figure\6h.pn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312" y="23148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3" descr="C:\Users\Maciek\Desktop\figure\vbnmtotal 6.png"/>
          <p:cNvPicPr preferRelativeResize="0"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0712" y="23148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31" descr="C:\Users\Maciek\Desktop\figure\6h1.png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6111" y="23148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2" descr="C:\Users\Maciek\Desktop\figure\ccvvb123.png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475" y="2314800"/>
            <a:ext cx="265088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29" descr="C:\Users\Maciek\Desktop\figure\zxcvbnmqwertt.png"/>
          <p:cNvPicPr>
            <a:picLocks noChangeAspect="1" noChangeArrowheads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312" y="34452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30" descr="C:\Users\Maciek\Desktop\figure\yui45.png"/>
          <p:cNvPicPr preferRelativeResize="0"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0712" y="34452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26" descr="C:\Users\Maciek\Desktop\figure\cvcccvvcvcvvcvc.png"/>
          <p:cNvPicPr>
            <a:picLocks noChangeAspect="1" noChangeArrowheads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6111" y="34452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29" descr="C:\Users\Maciek\Desktop\figure\nnnmphospho.png"/>
          <p:cNvPicPr preferRelativeResize="0">
            <a:picLocks noChangeArrowheads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475" y="34452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4" descr="C:\Users\Maciek\Desktop\figure\24hacidh2.png"/>
          <p:cNvPicPr>
            <a:picLocks noChangeAspect="1" noChangeArrowheads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6111" y="45720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C:\Users\Maciek\Desktop\figure\vnm8.png"/>
          <p:cNvPicPr preferRelativeResize="0">
            <a:picLocks noChangeArrowheads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475" y="4572000"/>
            <a:ext cx="2664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/>
          <p:cNvSpPr txBox="1"/>
          <p:nvPr/>
        </p:nvSpPr>
        <p:spPr>
          <a:xfrm rot="16200000">
            <a:off x="23697" y="4880960"/>
            <a:ext cx="699212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Acid 24h 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-47635" y="1539739"/>
            <a:ext cx="841879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0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37889" y="2656490"/>
            <a:ext cx="841879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6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-66742" y="3780067"/>
            <a:ext cx="899587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24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3192049" y="4912196"/>
            <a:ext cx="699212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Acid 24h 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3115509" y="1530031"/>
            <a:ext cx="841879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0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3116815" y="2653607"/>
            <a:ext cx="841879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6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094786" y="3790831"/>
            <a:ext cx="899587" cy="369324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endParaRPr lang="en-GB" sz="900" dirty="0">
              <a:solidFill>
                <a:srgbClr val="000000"/>
              </a:solidFill>
            </a:endParaRPr>
          </a:p>
          <a:p>
            <a:r>
              <a:rPr lang="en-GB" sz="900" dirty="0">
                <a:solidFill>
                  <a:srgbClr val="000000"/>
                </a:solidFill>
              </a:rPr>
              <a:t>+ </a:t>
            </a:r>
            <a:r>
              <a:rPr lang="en-GB" sz="900" dirty="0" smtClean="0">
                <a:solidFill>
                  <a:srgbClr val="000000"/>
                </a:solidFill>
              </a:rPr>
              <a:t>Collagen  24h</a:t>
            </a:r>
            <a:endParaRPr lang="en-GB" sz="900" dirty="0">
              <a:solidFill>
                <a:srgbClr val="000000"/>
              </a:solidFill>
            </a:endParaRPr>
          </a:p>
        </p:txBody>
      </p:sp>
      <p:sp>
        <p:nvSpPr>
          <p:cNvPr id="44" name="Rectangle 43"/>
          <p:cNvSpPr>
            <a:spLocks noChangeArrowheads="1"/>
          </p:cNvSpPr>
          <p:nvPr/>
        </p:nvSpPr>
        <p:spPr bwMode="auto">
          <a:xfrm>
            <a:off x="438057" y="1013566"/>
            <a:ext cx="444334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>
                <a:solidFill>
                  <a:srgbClr val="FF0000"/>
                </a:solidFill>
                <a:latin typeface="Calibri" panose="020F0502020204030204" pitchFamily="34" charset="0"/>
              </a:rPr>
              <a:t>DDR2</a:t>
            </a:r>
            <a:r>
              <a:rPr lang="en-GB" sz="800" b="1" dirty="0">
                <a:solidFill>
                  <a:srgbClr val="FF0000"/>
                </a:solidFill>
              </a:rPr>
              <a:t> </a:t>
            </a: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45" name="Rectangle 44"/>
          <p:cNvSpPr>
            <a:spLocks noChangeArrowheads="1"/>
          </p:cNvSpPr>
          <p:nvPr/>
        </p:nvSpPr>
        <p:spPr bwMode="auto">
          <a:xfrm>
            <a:off x="1212727" y="1013566"/>
            <a:ext cx="393038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</a:rPr>
              <a:t>DAPI</a:t>
            </a:r>
            <a:endParaRPr lang="en-GB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46" name="Rectangle 45"/>
          <p:cNvSpPr>
            <a:spLocks noChangeArrowheads="1"/>
          </p:cNvSpPr>
          <p:nvPr/>
        </p:nvSpPr>
        <p:spPr bwMode="auto">
          <a:xfrm>
            <a:off x="827330" y="1013566"/>
            <a:ext cx="420289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33CC33"/>
                </a:solidFill>
                <a:latin typeface="Calibri" panose="020F0502020204030204" pitchFamily="34" charset="0"/>
              </a:rPr>
              <a:t>EEA1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47" name="Rectangle 46"/>
          <p:cNvSpPr>
            <a:spLocks noChangeArrowheads="1"/>
          </p:cNvSpPr>
          <p:nvPr/>
        </p:nvSpPr>
        <p:spPr bwMode="auto">
          <a:xfrm>
            <a:off x="1835696" y="1009488"/>
            <a:ext cx="667152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P-Tyr-1000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48" name="Rectangle 47"/>
          <p:cNvSpPr>
            <a:spLocks noChangeArrowheads="1"/>
          </p:cNvSpPr>
          <p:nvPr/>
        </p:nvSpPr>
        <p:spPr bwMode="auto">
          <a:xfrm>
            <a:off x="2783509" y="1009488"/>
            <a:ext cx="393038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</a:rPr>
              <a:t>DAPI</a:t>
            </a:r>
            <a:endParaRPr lang="en-GB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49" name="Rectangle 48"/>
          <p:cNvSpPr>
            <a:spLocks noChangeArrowheads="1"/>
          </p:cNvSpPr>
          <p:nvPr/>
        </p:nvSpPr>
        <p:spPr bwMode="auto">
          <a:xfrm>
            <a:off x="2411760" y="1009488"/>
            <a:ext cx="420289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33CC33"/>
                </a:solidFill>
                <a:latin typeface="Calibri" panose="020F0502020204030204" pitchFamily="34" charset="0"/>
              </a:rPr>
              <a:t>EEA1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0" name="Rectangle 49"/>
          <p:cNvSpPr>
            <a:spLocks noChangeArrowheads="1"/>
          </p:cNvSpPr>
          <p:nvPr/>
        </p:nvSpPr>
        <p:spPr bwMode="auto">
          <a:xfrm>
            <a:off x="3598657" y="1009798"/>
            <a:ext cx="444334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DDR2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1" name="Rectangle 50"/>
          <p:cNvSpPr>
            <a:spLocks noChangeArrowheads="1"/>
          </p:cNvSpPr>
          <p:nvPr/>
        </p:nvSpPr>
        <p:spPr bwMode="auto">
          <a:xfrm>
            <a:off x="4370487" y="1009798"/>
            <a:ext cx="393038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</a:rPr>
              <a:t>DAPI</a:t>
            </a:r>
            <a:endParaRPr lang="en-GB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2" name="Rectangle 51"/>
          <p:cNvSpPr>
            <a:spLocks noChangeArrowheads="1"/>
          </p:cNvSpPr>
          <p:nvPr/>
        </p:nvSpPr>
        <p:spPr bwMode="auto">
          <a:xfrm>
            <a:off x="3938627" y="1009798"/>
            <a:ext cx="540514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33CC33"/>
                </a:solidFill>
                <a:latin typeface="Calibri" panose="020F0502020204030204" pitchFamily="34" charset="0"/>
              </a:rPr>
              <a:t>LAMP-1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3" name="Rectangle 52"/>
          <p:cNvSpPr>
            <a:spLocks noChangeArrowheads="1"/>
          </p:cNvSpPr>
          <p:nvPr/>
        </p:nvSpPr>
        <p:spPr bwMode="auto">
          <a:xfrm>
            <a:off x="5004048" y="1005720"/>
            <a:ext cx="667152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P-Tyr-1000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4" name="Rectangle 53"/>
          <p:cNvSpPr>
            <a:spLocks noChangeArrowheads="1"/>
          </p:cNvSpPr>
          <p:nvPr/>
        </p:nvSpPr>
        <p:spPr bwMode="auto">
          <a:xfrm>
            <a:off x="5979162" y="1005720"/>
            <a:ext cx="393038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</a:rPr>
              <a:t>DAPI</a:t>
            </a:r>
            <a:endParaRPr lang="en-GB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55" name="Rectangle 54"/>
          <p:cNvSpPr>
            <a:spLocks noChangeArrowheads="1"/>
          </p:cNvSpPr>
          <p:nvPr/>
        </p:nvSpPr>
        <p:spPr bwMode="auto">
          <a:xfrm>
            <a:off x="5543654" y="1005720"/>
            <a:ext cx="540514" cy="338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1" tIns="45716" rIns="91431" bIns="45716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solidFill>
                  <a:srgbClr val="33CC33"/>
                </a:solidFill>
                <a:latin typeface="Calibri" panose="020F0502020204030204" pitchFamily="34" charset="0"/>
              </a:rPr>
              <a:t>LAMP-1</a:t>
            </a:r>
            <a:r>
              <a:rPr lang="en-GB" sz="800" b="1" dirty="0" smtClean="0">
                <a:solidFill>
                  <a:srgbClr val="FF0000"/>
                </a:solidFill>
              </a:rPr>
              <a:t> </a:t>
            </a:r>
            <a:endParaRPr lang="en-GB" sz="800" b="1" dirty="0">
              <a:solidFill>
                <a:srgbClr val="FF0000"/>
              </a:solidFill>
            </a:endParaRPr>
          </a:p>
          <a:p>
            <a:pPr algn="ctr">
              <a:defRPr/>
            </a:pPr>
            <a:endParaRPr lang="en-GB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5981079" y="5593668"/>
            <a:ext cx="1224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5824591" y="5408636"/>
            <a:ext cx="605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chemeClr val="bg1"/>
                </a:solidFill>
              </a:rPr>
              <a:t>10</a:t>
            </a:r>
            <a:r>
              <a:rPr lang="en-GB" sz="7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700" b="1" dirty="0" smtClean="0">
                <a:solidFill>
                  <a:schemeClr val="bg1"/>
                </a:solidFill>
              </a:rPr>
              <a:t>m</a:t>
            </a:r>
            <a:endParaRPr lang="en-GB" sz="600" b="1" dirty="0">
              <a:solidFill>
                <a:schemeClr val="bg1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44168" y="760284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A</a:t>
            </a:r>
            <a:endParaRPr lang="en-GB" sz="11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3604424" y="749218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smtClean="0"/>
              <a:t>B</a:t>
            </a:r>
            <a:endParaRPr lang="en-GB" sz="1100" b="1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2828705" y="5608520"/>
            <a:ext cx="1224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2676980" y="5423488"/>
            <a:ext cx="6058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chemeClr val="bg1"/>
                </a:solidFill>
              </a:rPr>
              <a:t>10</a:t>
            </a:r>
            <a:r>
              <a:rPr lang="en-GB" sz="7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GB" sz="700" b="1" dirty="0" smtClean="0">
                <a:solidFill>
                  <a:schemeClr val="bg1"/>
                </a:solidFill>
              </a:rPr>
              <a:t>m</a:t>
            </a:r>
            <a:endParaRPr lang="en-GB" sz="600" b="1" dirty="0">
              <a:solidFill>
                <a:schemeClr val="bg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08188" y="154587"/>
            <a:ext cx="718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smtClean="0"/>
              <a:t>Figure </a:t>
            </a:r>
            <a:r>
              <a:rPr lang="en-GB" sz="1100" b="1" smtClean="0"/>
              <a:t>S5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661867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Huang</dc:creator>
  <cp:lastModifiedBy>Paul Huang</cp:lastModifiedBy>
  <cp:revision>6</cp:revision>
  <dcterms:created xsi:type="dcterms:W3CDTF">2017-09-08T15:17:59Z</dcterms:created>
  <dcterms:modified xsi:type="dcterms:W3CDTF">2018-04-05T21:53:27Z</dcterms:modified>
</cp:coreProperties>
</file>